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0C7E0C-416E-419C-91E6-A53014B2D11B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08BD3C-16F2-4670-ACE1-1374D495D69A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2A423B-5657-4A44-9E20-4A097D36769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04BF3B-C663-4B90-83CD-CD788FBE7F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065717-B66E-493F-A413-66A2507D23A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EB2C29-9E09-4D4B-8CBB-3B7DEC498AE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176FDC-8036-4883-8CB5-1C71D77994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E34031-BF6A-43C3-ACCF-3E2BA5AEED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E9361A-2252-43B1-8A9F-65462580F3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8883F5-E9CD-486E-9FAB-1F79033CF0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1B0E64-EA9B-4070-AC78-57E321F4BE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D9E9D9-B961-481B-B85B-AFB198C0E9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77B243-0068-41CE-83C7-4C484027B7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2988E7-A287-4987-8531-B17079BB78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254FD0-DC20-444B-90F5-7675926029C8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79"/>
          <p:cNvSpPr/>
          <p:nvPr/>
        </p:nvSpPr>
        <p:spPr>
          <a:xfrm>
            <a:off x="593640" y="7562880"/>
            <a:ext cx="6075360" cy="104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igure S1. A schematic diagram of the 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experimental design. 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Nannochloropsis 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cells are firstly grown to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ogarithmic phase under air enriched with 5% C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. After adaption to new environment under 5% C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for an hour,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Nannochloropsi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cells are then cultured under either 100 pm or 50,000 ppm C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concentration. Samples are collected at 0, 3, 6, 12 and 24 h from each condition (three biological replicate columns for each) by syringe for physiological characterization and multi-omics (transcriptome, proteome and metabolome) profiling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图片 1" descr=""/>
          <p:cNvPicPr/>
          <p:nvPr/>
        </p:nvPicPr>
        <p:blipFill>
          <a:blip r:embed="rId1"/>
          <a:stretch/>
        </p:blipFill>
        <p:spPr>
          <a:xfrm>
            <a:off x="1055520" y="631800"/>
            <a:ext cx="4746960" cy="6858000"/>
          </a:xfrm>
          <a:prstGeom prst="rect">
            <a:avLst/>
          </a:prstGeom>
          <a:ln w="0">
            <a:noFill/>
          </a:ln>
        </p:spPr>
      </p:pic>
      <p:sp>
        <p:nvSpPr>
          <p:cNvPr id="50" name="TextBox 1"/>
          <p:cNvSpPr/>
          <p:nvPr/>
        </p:nvSpPr>
        <p:spPr>
          <a:xfrm rot="5400000">
            <a:off x="5015880" y="6076800"/>
            <a:ext cx="29952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3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06T02:16:16Z</dcterms:created>
  <dc:creator>weili</dc:creator>
  <dc:description/>
  <dc:language>en-US</dc:language>
  <cp:lastModifiedBy>Srividya S</cp:lastModifiedBy>
  <dcterms:modified xsi:type="dcterms:W3CDTF">2019-06-19T13:04:07Z</dcterms:modified>
  <cp:revision>535</cp:revision>
  <dc:subject/>
  <dc:title>Main figure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5184</vt:lpwstr>
  </property>
</Properties>
</file>